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220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B2406C-6097-4410-8423-BE16AEE9E6F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3A6A2F-2681-4348-B28D-0F0216C8E3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21580F-76F7-44A0-ABB1-C84D54E87CD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BE4C7D-0D56-4217-82CB-5E0819EF7A1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F04A12-1B7D-4C21-BCAE-B5A9C9C1BE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D4DC20-E72B-434E-A5AC-1AF5D756FA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6E6A76-EECA-4BDC-B2EF-93D912D274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7D8460-3C1F-48FE-902A-0B6AB1C326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8FA4F1-2071-4A38-91DC-DFBBB5AC27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3C31FC-FC0C-4653-98F9-493CA062E0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4F8FE3-A352-4F93-A590-363818C7BD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697AC9-9A3D-42EC-BFA2-2C58B41CA0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B54D85D-FBEA-4A8E-BE16-2CB990C58A3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762120" y="617220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.S1:  A subset of doublets shows proximal spacing and fits to exponential distribution in th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GFR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5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gen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994040" y="3048120"/>
          <a:ext cx="5397480" cy="28191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994040" y="3048120"/>
                    <a:ext cx="5397480" cy="2819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4" name=""/>
          <p:cNvGraphicFramePr/>
          <p:nvPr/>
        </p:nvGraphicFramePr>
        <p:xfrm>
          <a:off x="1981080" y="152280"/>
          <a:ext cx="5334120" cy="281952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5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981080" y="152280"/>
                    <a:ext cx="5334120" cy="2819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9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7-07T22:08:48Z</dcterms:created>
  <dc:creator>zhchen</dc:creator>
  <dc:description/>
  <dc:language>en-US</dc:language>
  <cp:lastModifiedBy>cbuzin</cp:lastModifiedBy>
  <dcterms:modified xsi:type="dcterms:W3CDTF">2008-10-21T17:59:22Z</dcterms:modified>
  <cp:revision>64</cp:revision>
  <dc:subject/>
  <dc:title>Slide 1</dc:title>
</cp:coreProperties>
</file>